
<file path=[Content_Types].xml><?xml version="1.0" encoding="utf-8"?>
<Types xmlns="http://schemas.openxmlformats.org/package/2006/content-types">
  <Default Extension="avi" ContentType="video/x-msvideo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5" r:id="rId2"/>
    <p:sldId id="26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67" autoAdjust="0"/>
    <p:restoredTop sz="96247" autoAdjust="0"/>
  </p:normalViewPr>
  <p:slideViewPr>
    <p:cSldViewPr snapToGrid="0">
      <p:cViewPr>
        <p:scale>
          <a:sx n="66" d="100"/>
          <a:sy n="66" d="100"/>
        </p:scale>
        <p:origin x="3648" y="4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E8BC70-5E3E-44BE-9FA1-A628D68CDA56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C9780D-CA45-4779-B7BC-FBCC3152CD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4058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911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7106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1288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2763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7977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2695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902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409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6816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748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413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048C5-26EC-4819-9EFA-6D89B64095EF}" type="datetimeFigureOut">
              <a:rPr lang="de-DE" smtClean="0"/>
              <a:t>05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49932-8A07-46DA-BF28-F839AC01CD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017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avi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3.png"/><Relationship Id="rId4" Type="http://schemas.openxmlformats.org/officeDocument/2006/relationships/video" Target="../media/media2.avi"/><Relationship Id="rId9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>
            <a:extLst>
              <a:ext uri="{FF2B5EF4-FFF2-40B4-BE49-F238E27FC236}">
                <a16:creationId xmlns:a16="http://schemas.microsoft.com/office/drawing/2014/main" id="{2CCCEAA1-9792-4A02-A089-B4625F8B6C3B}"/>
              </a:ext>
            </a:extLst>
          </p:cNvPr>
          <p:cNvSpPr txBox="1"/>
          <p:nvPr/>
        </p:nvSpPr>
        <p:spPr>
          <a:xfrm>
            <a:off x="0" y="-1734"/>
            <a:ext cx="2621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Movie S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2019 08 30 FITmSS271AA-GFP time series 1 as C">
            <a:hlinkClick r:id="" action="ppaction://media"/>
            <a:extLst>
              <a:ext uri="{FF2B5EF4-FFF2-40B4-BE49-F238E27FC236}">
                <a16:creationId xmlns:a16="http://schemas.microsoft.com/office/drawing/2014/main" id="{3B66F729-6333-4017-9921-525991A4863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793875" y="6876436"/>
            <a:ext cx="2880000" cy="2880000"/>
          </a:xfrm>
          <a:prstGeom prst="rect">
            <a:avLst/>
          </a:prstGeom>
        </p:spPr>
      </p:pic>
      <p:pic>
        <p:nvPicPr>
          <p:cNvPr id="5" name="2020 05 28 FIT-GFP 3 time series with -G">
            <a:hlinkClick r:id="" action="ppaction://media"/>
            <a:extLst>
              <a:ext uri="{FF2B5EF4-FFF2-40B4-BE49-F238E27FC236}">
                <a16:creationId xmlns:a16="http://schemas.microsoft.com/office/drawing/2014/main" id="{31D67097-E07E-4455-B215-40E15D045CCC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1793875" y="454568"/>
            <a:ext cx="2880000" cy="2880000"/>
          </a:xfrm>
          <a:prstGeom prst="rect">
            <a:avLst/>
          </a:prstGeom>
        </p:spPr>
      </p:pic>
      <p:pic>
        <p:nvPicPr>
          <p:cNvPr id="6" name="2020 05 28 ZAT12-GFP 2 time series with -G">
            <a:hlinkClick r:id="" action="ppaction://media"/>
            <a:extLst>
              <a:ext uri="{FF2B5EF4-FFF2-40B4-BE49-F238E27FC236}">
                <a16:creationId xmlns:a16="http://schemas.microsoft.com/office/drawing/2014/main" id="{D241EEBF-536A-4CD6-8C0E-4CD4255AB42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1793875" y="3647112"/>
            <a:ext cx="288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71517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57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1157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157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A1B3BD4D-A166-41C1-A409-BEC15AD0C5E1}"/>
              </a:ext>
            </a:extLst>
          </p:cNvPr>
          <p:cNvSpPr txBox="1"/>
          <p:nvPr/>
        </p:nvSpPr>
        <p:spPr>
          <a:xfrm>
            <a:off x="0" y="0"/>
            <a:ext cx="6858000" cy="3059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Movie S1. Light induction triggers the formation of NBs with FIT and FITmSS271AA with different dynamics. (Supports Figure 1 and 2)</a:t>
            </a:r>
            <a:endParaRPr lang="de-DE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indent="449580" algn="just">
              <a:lnSpc>
                <a:spcPct val="150000"/>
              </a:lnSpc>
              <a:spcAft>
                <a:spcPts val="800"/>
              </a:spcAft>
            </a:pP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me series showing representative localization of A, FIT-GFP, B, ZAT12-GFP, and C, FITmSS271AA-GFP, each of them from 0 to 20 min after the light trigger in the nucleus. Pictures were taken in 15-sec intervals. FIT-GFP accumulated in NBs within the first minutes after light excitation. ZAT12-GFP did not show NB formation and was a negative control to show that GFP did not cause the NB effect. FITmSS271AA-GFP accumulated late in NBs (starting at 10 min), which were also smaller in size, indicating that Ser271/272 is important. </a:t>
            </a:r>
            <a:endParaRPr lang="de-DE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indent="449580" algn="just">
              <a:lnSpc>
                <a:spcPct val="150000"/>
              </a:lnSpc>
              <a:spcAft>
                <a:spcPts val="800"/>
              </a:spcAft>
            </a:pP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 bar: 2 µm. G = GFP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luorescence protein analysis was conducted in transiently transformed </a:t>
            </a:r>
            <a:r>
              <a:rPr lang="en-US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. </a:t>
            </a:r>
            <a:r>
              <a:rPr lang="en-US" sz="1100" i="1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nthamiana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eaf epidermis cells, following the standardized FIT NB analysis procedure. Two independent time series experiments were conducted per </a:t>
            </a:r>
            <a:r>
              <a:rPr lang="en-US" sz="1100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struct. </a:t>
            </a:r>
            <a:endParaRPr lang="de-DE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1874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2</Words>
  <Application>Microsoft Office PowerPoint</Application>
  <PresentationFormat>A4-Papier (210 x 297 mm)</PresentationFormat>
  <Paragraphs>4</Paragraphs>
  <Slides>2</Slides>
  <Notes>0</Notes>
  <HiddenSlides>0</HiddenSlides>
  <MMClips>3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senia</dc:creator>
  <cp:lastModifiedBy>Ksenia Trofimov</cp:lastModifiedBy>
  <cp:revision>310</cp:revision>
  <dcterms:created xsi:type="dcterms:W3CDTF">2019-10-01T07:26:16Z</dcterms:created>
  <dcterms:modified xsi:type="dcterms:W3CDTF">2023-05-05T13:29:52Z</dcterms:modified>
</cp:coreProperties>
</file>